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changesInfos/changesInfo1.xml" ContentType="application/vnd.ms-powerpoint.changesinfo+xml"/>
  <Override PartName="/ppt/revisionInfo.xml" ContentType="application/vnd.ms-powerpoint.revision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  <p:sldId id="258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0D3322FA-2BE6-4643-9937-B0609DA7D8F4}" v="2" dt="2023-06-15T12:59:06.566"/>
    <p1510:client id="{E0CFBCA0-D047-4670-9446-F69DE4321F42}" v="159" dt="2023-06-16T13:02:18.670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9972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108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10" Type="http://schemas.microsoft.com/office/2015/10/relationships/revisionInfo" Target="revisionInfo.xml"/><Relationship Id="rId4" Type="http://schemas.openxmlformats.org/officeDocument/2006/relationships/slide" Target="slides/slide3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Gayani Perera" clId="Web-{E0CFBCA0-D047-4670-9446-F69DE4321F42}"/>
    <pc:docChg chg="addSld modSld">
      <pc:chgData name="Gayani Perera" userId="" providerId="" clId="Web-{E0CFBCA0-D047-4670-9446-F69DE4321F42}" dt="2023-06-16T13:02:17.467" v="93" actId="20577"/>
      <pc:docMkLst>
        <pc:docMk/>
      </pc:docMkLst>
      <pc:sldChg chg="addSp delSp modSp">
        <pc:chgData name="Gayani Perera" userId="" providerId="" clId="Web-{E0CFBCA0-D047-4670-9446-F69DE4321F42}" dt="2023-06-16T13:02:17.467" v="93" actId="20577"/>
        <pc:sldMkLst>
          <pc:docMk/>
          <pc:sldMk cId="109857222" sldId="256"/>
        </pc:sldMkLst>
        <pc:spChg chg="add mod">
          <ac:chgData name="Gayani Perera" userId="" providerId="" clId="Web-{E0CFBCA0-D047-4670-9446-F69DE4321F42}" dt="2023-06-16T13:02:17.467" v="93" actId="20577"/>
          <ac:spMkLst>
            <pc:docMk/>
            <pc:sldMk cId="109857222" sldId="256"/>
            <ac:spMk id="6" creationId="{A2EC27DC-689C-0A68-4E60-6AEA3E5781F3}"/>
          </ac:spMkLst>
        </pc:spChg>
        <pc:picChg chg="add del mod">
          <ac:chgData name="Gayani Perera" userId="" providerId="" clId="Web-{E0CFBCA0-D047-4670-9446-F69DE4321F42}" dt="2023-06-16T12:57:06.188" v="8"/>
          <ac:picMkLst>
            <pc:docMk/>
            <pc:sldMk cId="109857222" sldId="256"/>
            <ac:picMk id="2" creationId="{74AEB16E-DDE6-5202-FCD8-402B92353A29}"/>
          </ac:picMkLst>
        </pc:picChg>
        <pc:picChg chg="add mod">
          <ac:chgData name="Gayani Perera" userId="" providerId="" clId="Web-{E0CFBCA0-D047-4670-9446-F69DE4321F42}" dt="2023-06-16T12:57:40.721" v="18" actId="1076"/>
          <ac:picMkLst>
            <pc:docMk/>
            <pc:sldMk cId="109857222" sldId="256"/>
            <ac:picMk id="3" creationId="{935EF40C-3CC2-471A-1D41-2C67F6D237E2}"/>
          </ac:picMkLst>
        </pc:picChg>
        <pc:picChg chg="add del mod">
          <ac:chgData name="Gayani Perera" userId="" providerId="" clId="Web-{E0CFBCA0-D047-4670-9446-F69DE4321F42}" dt="2023-06-16T12:57:34.783" v="17"/>
          <ac:picMkLst>
            <pc:docMk/>
            <pc:sldMk cId="109857222" sldId="256"/>
            <ac:picMk id="4" creationId="{666DECA8-853C-F3E3-5244-BF5840AE2EEE}"/>
          </ac:picMkLst>
        </pc:picChg>
      </pc:sldChg>
      <pc:sldChg chg="addSp delSp modSp new">
        <pc:chgData name="Gayani Perera" userId="" providerId="" clId="Web-{E0CFBCA0-D047-4670-9446-F69DE4321F42}" dt="2023-06-16T13:01:50.810" v="88" actId="20577"/>
        <pc:sldMkLst>
          <pc:docMk/>
          <pc:sldMk cId="3998537528" sldId="257"/>
        </pc:sldMkLst>
        <pc:spChg chg="add mod">
          <ac:chgData name="Gayani Perera" userId="" providerId="" clId="Web-{E0CFBCA0-D047-4670-9446-F69DE4321F42}" dt="2023-06-16T13:01:50.810" v="88" actId="20577"/>
          <ac:spMkLst>
            <pc:docMk/>
            <pc:sldMk cId="3998537528" sldId="257"/>
            <ac:spMk id="5" creationId="{EC12B5DD-ABB2-C9C1-5AEE-DAA161ACC676}"/>
          </ac:spMkLst>
        </pc:spChg>
        <pc:picChg chg="add del mod">
          <ac:chgData name="Gayani Perera" userId="" providerId="" clId="Web-{E0CFBCA0-D047-4670-9446-F69DE4321F42}" dt="2023-06-16T12:57:03.110" v="7"/>
          <ac:picMkLst>
            <pc:docMk/>
            <pc:sldMk cId="3998537528" sldId="257"/>
            <ac:picMk id="2" creationId="{EA6D801D-6849-31B4-DDD0-68777C0CD15A}"/>
          </ac:picMkLst>
        </pc:picChg>
        <pc:picChg chg="add mod">
          <ac:chgData name="Gayani Perera" userId="" providerId="" clId="Web-{E0CFBCA0-D047-4670-9446-F69DE4321F42}" dt="2023-06-16T12:58:06.316" v="19" actId="1076"/>
          <ac:picMkLst>
            <pc:docMk/>
            <pc:sldMk cId="3998537528" sldId="257"/>
            <ac:picMk id="4" creationId="{089BE749-829B-14CC-D3CE-7323FFA22D2B}"/>
          </ac:picMkLst>
        </pc:picChg>
      </pc:sldChg>
    </pc:docChg>
  </pc:docChgLst>
  <pc:docChgLst>
    <pc:chgData name="Gayani Perera" userId="zAPAmXEaXMHYP/VkoQ8rUimoVo5ZBSPzaIgeOcNdqiM=" providerId="None" clId="Web-{0D3322FA-2BE6-4643-9937-B0609DA7D8F4}"/>
    <pc:docChg chg="modSld">
      <pc:chgData name="Gayani Perera" userId="zAPAmXEaXMHYP/VkoQ8rUimoVo5ZBSPzaIgeOcNdqiM=" providerId="None" clId="Web-{0D3322FA-2BE6-4643-9937-B0609DA7D8F4}" dt="2023-06-15T12:59:06.566" v="1"/>
      <pc:docMkLst>
        <pc:docMk/>
      </pc:docMkLst>
      <pc:sldChg chg="delSp">
        <pc:chgData name="Gayani Perera" userId="zAPAmXEaXMHYP/VkoQ8rUimoVo5ZBSPzaIgeOcNdqiM=" providerId="None" clId="Web-{0D3322FA-2BE6-4643-9937-B0609DA7D8F4}" dt="2023-06-15T12:59:06.566" v="1"/>
        <pc:sldMkLst>
          <pc:docMk/>
          <pc:sldMk cId="109857222" sldId="256"/>
        </pc:sldMkLst>
        <pc:spChg chg="del">
          <ac:chgData name="Gayani Perera" userId="zAPAmXEaXMHYP/VkoQ8rUimoVo5ZBSPzaIgeOcNdqiM=" providerId="None" clId="Web-{0D3322FA-2BE6-4643-9937-B0609DA7D8F4}" dt="2023-06-15T12:59:06.269" v="0"/>
          <ac:spMkLst>
            <pc:docMk/>
            <pc:sldMk cId="109857222" sldId="256"/>
            <ac:spMk id="2" creationId="{00000000-0000-0000-0000-000000000000}"/>
          </ac:spMkLst>
        </pc:spChg>
        <pc:spChg chg="del">
          <ac:chgData name="Gayani Perera" userId="zAPAmXEaXMHYP/VkoQ8rUimoVo5ZBSPzaIgeOcNdqiM=" providerId="None" clId="Web-{0D3322FA-2BE6-4643-9937-B0609DA7D8F4}" dt="2023-06-15T12:59:06.566" v="1"/>
          <ac:spMkLst>
            <pc:docMk/>
            <pc:sldMk cId="109857222" sldId="256"/>
            <ac:spMk id="3" creationId="{00000000-0000-0000-0000-000000000000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7/1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53878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7/1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29054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7/1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94456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7/1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91384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7/1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15245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7/13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30920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7/13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31723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7/13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03125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7/13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63889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7/13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18414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7/13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89582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6CE7D5-CF57-46EF-B807-FDD0502418D4}" type="datetimeFigureOut">
              <a:rPr lang="en-US" smtClean="0"/>
              <a:t>7/1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09540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3431275" y="479849"/>
            <a:ext cx="5329451" cy="5898303"/>
            <a:chOff x="3235089" y="416913"/>
            <a:chExt cx="5329451" cy="5898303"/>
          </a:xfrm>
        </p:grpSpPr>
        <p:pic>
          <p:nvPicPr>
            <p:cNvPr id="4" name="Picture 3" descr="Chart, scatter chart&#10;&#10;Description automatically generated">
              <a:extLst>
                <a:ext uri="{FF2B5EF4-FFF2-40B4-BE49-F238E27FC236}">
                  <a16:creationId xmlns:a16="http://schemas.microsoft.com/office/drawing/2014/main" xmlns="" id="{935EF40C-3CC2-471A-1D41-2C67F6D237E2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237364" y="416913"/>
              <a:ext cx="5324901" cy="5313528"/>
            </a:xfrm>
            <a:prstGeom prst="rect">
              <a:avLst/>
            </a:prstGeom>
          </p:spPr>
        </p:pic>
        <p:sp>
          <p:nvSpPr>
            <p:cNvPr id="5" name="TextBox 4">
              <a:extLst>
                <a:ext uri="{FF2B5EF4-FFF2-40B4-BE49-F238E27FC236}">
                  <a16:creationId xmlns:a16="http://schemas.microsoft.com/office/drawing/2014/main" xmlns="" id="{A2EC27DC-689C-0A68-4E60-6AEA3E5781F3}"/>
                </a:ext>
              </a:extLst>
            </p:cNvPr>
            <p:cNvSpPr txBox="1"/>
            <p:nvPr/>
          </p:nvSpPr>
          <p:spPr>
            <a:xfrm>
              <a:off x="3235089" y="5730441"/>
              <a:ext cx="5329451" cy="584775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spAutoFit/>
            </a:bodyPr>
            <a:lstStyle/>
            <a:p>
              <a:r>
                <a:rPr lang="en-US" sz="1600" b="1" dirty="0">
                  <a:cs typeface="Calibri"/>
                </a:rPr>
                <a:t>Figure S1. </a:t>
              </a:r>
              <a:r>
                <a:rPr lang="en-US" sz="1600" dirty="0">
                  <a:cs typeface="Calibri"/>
                </a:rPr>
                <a:t>UMAP plot of Cells Labeled by Cluster: Each dot represents a single nucleus colored by is cluster identity. </a:t>
              </a:r>
              <a:endParaRPr lang="en-US" sz="1600" dirty="0"/>
            </a:p>
          </p:txBody>
        </p:sp>
      </p:grpSp>
    </p:spTree>
    <p:extLst>
      <p:ext uri="{BB962C8B-B14F-4D97-AF65-F5344CB8AC3E}">
        <p14:creationId xmlns:p14="http://schemas.microsoft.com/office/powerpoint/2010/main" val="10985722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3431275" y="356738"/>
            <a:ext cx="5329451" cy="6144525"/>
            <a:chOff x="3426189" y="466340"/>
            <a:chExt cx="5329451" cy="6144525"/>
          </a:xfrm>
        </p:grpSpPr>
        <p:pic>
          <p:nvPicPr>
            <p:cNvPr id="4" name="Picture 4" descr="Chart, scatter chart&#10;&#10;Description automatically generated">
              <a:extLst>
                <a:ext uri="{FF2B5EF4-FFF2-40B4-BE49-F238E27FC236}">
                  <a16:creationId xmlns:a16="http://schemas.microsoft.com/office/drawing/2014/main" xmlns="" id="{089BE749-829B-14CC-D3CE-7323FFA22D2B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428464" y="466340"/>
              <a:ext cx="5324901" cy="5313528"/>
            </a:xfrm>
            <a:prstGeom prst="rect">
              <a:avLst/>
            </a:prstGeom>
          </p:spPr>
        </p:pic>
        <p:sp>
          <p:nvSpPr>
            <p:cNvPr id="5" name="TextBox 4">
              <a:extLst>
                <a:ext uri="{FF2B5EF4-FFF2-40B4-BE49-F238E27FC236}">
                  <a16:creationId xmlns:a16="http://schemas.microsoft.com/office/drawing/2014/main" xmlns="" id="{EC12B5DD-ABB2-C9C1-5AEE-DAA161ACC676}"/>
                </a:ext>
              </a:extLst>
            </p:cNvPr>
            <p:cNvSpPr txBox="1"/>
            <p:nvPr/>
          </p:nvSpPr>
          <p:spPr>
            <a:xfrm>
              <a:off x="3426189" y="5779868"/>
              <a:ext cx="5329451" cy="830997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spAutoFit/>
            </a:bodyPr>
            <a:lstStyle/>
            <a:p>
              <a:r>
                <a:rPr lang="en-US" sz="1600" b="1" dirty="0">
                  <a:cs typeface="Calibri"/>
                </a:rPr>
                <a:t>Figure S2. </a:t>
              </a:r>
              <a:r>
                <a:rPr lang="en-US" sz="1600" dirty="0">
                  <a:cs typeface="Calibri"/>
                </a:rPr>
                <a:t>UMAP plot of Cells Labeled by Cell Type and Separated by Genotype: Each dot represents a single nucleus colored by is cell identity. </a:t>
              </a:r>
              <a:endParaRPr lang="en-US" sz="1600" dirty="0"/>
            </a:p>
          </p:txBody>
        </p:sp>
      </p:grpSp>
    </p:spTree>
    <p:extLst>
      <p:ext uri="{BB962C8B-B14F-4D97-AF65-F5344CB8AC3E}">
        <p14:creationId xmlns:p14="http://schemas.microsoft.com/office/powerpoint/2010/main" val="399853752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 5"/>
          <p:cNvGrpSpPr/>
          <p:nvPr/>
        </p:nvGrpSpPr>
        <p:grpSpPr>
          <a:xfrm>
            <a:off x="3190211" y="1288"/>
            <a:ext cx="5811579" cy="6855424"/>
            <a:chOff x="3129992" y="605019"/>
            <a:chExt cx="5811579" cy="6855424"/>
          </a:xfrm>
        </p:grpSpPr>
        <p:pic>
          <p:nvPicPr>
            <p:cNvPr id="4" name="Picture 3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392899" y="605019"/>
              <a:ext cx="5285764" cy="5285764"/>
            </a:xfrm>
            <a:prstGeom prst="rect">
              <a:avLst/>
            </a:prstGeom>
          </p:spPr>
        </p:pic>
        <p:sp>
          <p:nvSpPr>
            <p:cNvPr id="5" name="TextBox 4">
              <a:extLst>
                <a:ext uri="{FF2B5EF4-FFF2-40B4-BE49-F238E27FC236}">
                  <a16:creationId xmlns:a16="http://schemas.microsoft.com/office/drawing/2014/main" xmlns="" id="{EC12B5DD-ABB2-C9C1-5AEE-DAA161ACC676}"/>
                </a:ext>
              </a:extLst>
            </p:cNvPr>
            <p:cNvSpPr txBox="1"/>
            <p:nvPr/>
          </p:nvSpPr>
          <p:spPr>
            <a:xfrm>
              <a:off x="3129992" y="5890783"/>
              <a:ext cx="5811579" cy="1569660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spAutoFit/>
            </a:bodyPr>
            <a:lstStyle/>
            <a:p>
              <a:r>
                <a:rPr lang="en-US" sz="1600" b="1" dirty="0">
                  <a:cs typeface="Calibri"/>
                </a:rPr>
                <a:t>Figure </a:t>
              </a:r>
              <a:r>
                <a:rPr lang="en-US" sz="1600" b="1" dirty="0" smtClean="0">
                  <a:cs typeface="Calibri"/>
                </a:rPr>
                <a:t>S3. </a:t>
              </a:r>
              <a:r>
                <a:rPr lang="en-US" sz="1600" dirty="0" smtClean="0">
                  <a:cs typeface="Calibri"/>
                </a:rPr>
                <a:t>Boxplots representing the distribution of the Cell </a:t>
              </a:r>
              <a:r>
                <a:rPr lang="en-US" sz="1600" dirty="0">
                  <a:cs typeface="Calibri"/>
                </a:rPr>
                <a:t>T</a:t>
              </a:r>
              <a:r>
                <a:rPr lang="en-US" sz="1600" dirty="0" smtClean="0">
                  <a:cs typeface="Calibri"/>
                </a:rPr>
                <a:t>ype </a:t>
              </a:r>
              <a:r>
                <a:rPr lang="en-US" sz="1600" dirty="0">
                  <a:cs typeface="Calibri"/>
                </a:rPr>
                <a:t>D</a:t>
              </a:r>
              <a:r>
                <a:rPr lang="en-US" sz="1600" dirty="0" smtClean="0">
                  <a:cs typeface="Calibri"/>
                </a:rPr>
                <a:t>iversity Statistic in WT and </a:t>
              </a:r>
              <a:r>
                <a:rPr lang="en-US" sz="1600" dirty="0" err="1" smtClean="0">
                  <a:cs typeface="Calibri"/>
                </a:rPr>
                <a:t>Taz</a:t>
              </a:r>
              <a:r>
                <a:rPr lang="en-US" sz="1600" dirty="0" smtClean="0">
                  <a:cs typeface="Calibri"/>
                </a:rPr>
                <a:t>-KO mice: The cell type diversity statistic can range between -1 and 0 with values closer to zero indicating greater cell type diversity. There was no statistically significant difference of the diversity statistic across genotypes (t-test p-value = 0.66). </a:t>
              </a:r>
              <a:r>
                <a:rPr lang="en-US" sz="1600" dirty="0">
                  <a:cs typeface="Calibri"/>
                </a:rPr>
                <a:t> </a:t>
              </a:r>
              <a:endParaRPr lang="en-US" sz="1600" dirty="0"/>
            </a:p>
          </p:txBody>
        </p:sp>
      </p:grpSp>
    </p:spTree>
    <p:extLst>
      <p:ext uri="{BB962C8B-B14F-4D97-AF65-F5344CB8AC3E}">
        <p14:creationId xmlns:p14="http://schemas.microsoft.com/office/powerpoint/2010/main" val="43638406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64</TotalTime>
  <Words>111</Words>
  <Application>Microsoft Office PowerPoint</Application>
  <PresentationFormat>Widescreen</PresentationFormat>
  <Paragraphs>3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erera, Gayani</dc:creator>
  <cp:lastModifiedBy>Perera, Gayani</cp:lastModifiedBy>
  <cp:revision>39</cp:revision>
  <dcterms:created xsi:type="dcterms:W3CDTF">2023-06-15T12:58:51Z</dcterms:created>
  <dcterms:modified xsi:type="dcterms:W3CDTF">2023-07-13T20:26:29Z</dcterms:modified>
</cp:coreProperties>
</file>